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B0C8DA-9B89-4DFD-ABD7-6152DB4BC90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48D2F7-1D6D-4608-8B18-09C410E27CE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224658-9A1F-4D67-916E-810B8ABE620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D94711-8D3D-4310-BF45-24490B72156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DFCCB7-AD5B-4C38-86B8-433E81A1637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969DC5-3505-4B5F-BE04-462E46484EA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9C79F8-0AB4-4BDC-8187-DFBE29DDA5B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24A3A3-5936-431D-836C-168AA25FAFA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ECC6B5-80CE-4871-A986-E734589FD27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F142B7-0AD2-4D94-A95A-4A1006A24A2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F737C0-538D-4E28-B0DC-5D6DB1E357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13123B-384C-4756-9220-320D2AD3FBB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F17909A-F1F0-48EF-AE73-98977B1F9D95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hylogenetic relationship of salmonids and relevant teleost lineage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5" descr="D:\PPT_Out\nature-logo.jpg"/>
          <p:cNvPicPr/>
          <p:nvPr/>
        </p:nvPicPr>
        <p:blipFill>
          <a:blip r:embed="rId1"/>
          <a:stretch/>
        </p:blipFill>
        <p:spPr>
          <a:xfrm>
            <a:off x="6985080" y="6222960"/>
            <a:ext cx="1333440" cy="279360"/>
          </a:xfrm>
          <a:prstGeom prst="rect">
            <a:avLst/>
          </a:prstGeom>
          <a:ln w="0">
            <a:noFill/>
          </a:ln>
        </p:spPr>
      </p:pic>
      <p:sp>
        <p:nvSpPr>
          <p:cNvPr id="43" name="Title 1"/>
          <p:cNvSpPr/>
          <p:nvPr/>
        </p:nvSpPr>
        <p:spPr>
          <a:xfrm>
            <a:off x="444600" y="5851440"/>
            <a:ext cx="822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S Lien</a:t>
            </a:r>
            <a:r>
              <a:rPr b="0" i="1" lang="fr-FR" sz="1200" spc="-1" strike="noStrike">
                <a:solidFill>
                  <a:srgbClr val="000000"/>
                </a:solidFill>
                <a:latin typeface="Arial"/>
              </a:rPr>
              <a:t> et al. Nature</a:t>
            </a: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1–6 (2016) doi:10.1038/nature1716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4" name="Picture 6" descr="N:\www.nature.com\nature\journal\vaop\ncurrent\images_hires\nature17164-f1.jpg"/>
          <p:cNvPicPr/>
          <p:nvPr/>
        </p:nvPicPr>
        <p:blipFill>
          <a:blip r:embed="rId2"/>
          <a:stretch/>
        </p:blipFill>
        <p:spPr>
          <a:xfrm>
            <a:off x="1143000" y="1219320"/>
            <a:ext cx="693432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4-12T09:46:30Z</dcterms:created>
  <dc:creator>ravikumar.n</dc:creator>
  <dc:description/>
  <dc:language>en-US</dc:language>
  <cp:lastModifiedBy>Mankoo, Manpreet</cp:lastModifiedBy>
  <dcterms:modified xsi:type="dcterms:W3CDTF">2016-04-15T11:23:48Z</dcterms:modified>
  <cp:revision>3</cp:revision>
  <dc:subject/>
  <dc:title>Phylogenetic relationship of salmonids and relevant teleost lineages</dc:title>
</cp:coreProperties>
</file>